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12192000" cy="946785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43" autoAdjust="0"/>
    <p:restoredTop sz="94660"/>
  </p:normalViewPr>
  <p:slideViewPr>
    <p:cSldViewPr snapToGrid="0">
      <p:cViewPr>
        <p:scale>
          <a:sx n="50" d="100"/>
          <a:sy n="50" d="100"/>
        </p:scale>
        <p:origin x="1284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549485"/>
            <a:ext cx="10363200" cy="3296214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972814"/>
            <a:ext cx="9144000" cy="2285871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CF1E-7AA4-4E42-A424-C38EAB80E52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229F9-B25F-451A-B756-CC9285415E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64673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CF1E-7AA4-4E42-A424-C38EAB80E52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229F9-B25F-451A-B756-CC9285415E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0711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504075"/>
            <a:ext cx="2628900" cy="802356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504075"/>
            <a:ext cx="7734300" cy="802356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CF1E-7AA4-4E42-A424-C38EAB80E52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229F9-B25F-451A-B756-CC9285415E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13342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CF1E-7AA4-4E42-A424-C38EAB80E52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229F9-B25F-451A-B756-CC9285415E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37020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360390"/>
            <a:ext cx="10515600" cy="3938362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336011"/>
            <a:ext cx="10515600" cy="2071091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CF1E-7AA4-4E42-A424-C38EAB80E52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229F9-B25F-451A-B756-CC9285415E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31664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520377"/>
            <a:ext cx="5181600" cy="600726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520377"/>
            <a:ext cx="5181600" cy="600726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CF1E-7AA4-4E42-A424-C38EAB80E52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229F9-B25F-451A-B756-CC9285415E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0587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04078"/>
            <a:ext cx="10515600" cy="183001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320939"/>
            <a:ext cx="5157787" cy="113745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458395"/>
            <a:ext cx="5157787" cy="508677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320939"/>
            <a:ext cx="5183188" cy="113745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458395"/>
            <a:ext cx="5183188" cy="508677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CF1E-7AA4-4E42-A424-C38EAB80E52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229F9-B25F-451A-B756-CC9285415E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3142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CF1E-7AA4-4E42-A424-C38EAB80E52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229F9-B25F-451A-B756-CC9285415E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404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CF1E-7AA4-4E42-A424-C38EAB80E52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229F9-B25F-451A-B756-CC9285415E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19493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31190"/>
            <a:ext cx="3932237" cy="2209165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363197"/>
            <a:ext cx="6172200" cy="6728310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840355"/>
            <a:ext cx="3932237" cy="5262109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CF1E-7AA4-4E42-A424-C38EAB80E52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229F9-B25F-451A-B756-CC9285415E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2420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31190"/>
            <a:ext cx="3932237" cy="2209165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363197"/>
            <a:ext cx="6172200" cy="6728310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840355"/>
            <a:ext cx="3932237" cy="5262109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CF1E-7AA4-4E42-A424-C38EAB80E52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229F9-B25F-451A-B756-CC9285415E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350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504078"/>
            <a:ext cx="10515600" cy="183001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520377"/>
            <a:ext cx="10515600" cy="600726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775297"/>
            <a:ext cx="2743200" cy="5040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B4CF1E-7AA4-4E42-A424-C38EAB80E52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775297"/>
            <a:ext cx="4114800" cy="5040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775297"/>
            <a:ext cx="2743200" cy="5040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D229F9-B25F-451A-B756-CC9285415E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1147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704684" y="8214160"/>
            <a:ext cx="10762150" cy="8069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96" b="1" dirty="0" smtClean="0">
                <a:latin typeface="Times New Roman" pitchFamily="18" charset="0"/>
                <a:cs typeface="Times New Roman" pitchFamily="18" charset="0"/>
              </a:rPr>
              <a:t>S3 Fig. </a:t>
            </a:r>
            <a:r>
              <a:rPr lang="en-US" altLang="zh-CN" sz="1496" dirty="0" smtClean="0">
                <a:latin typeface="Times New Roman" pitchFamily="18" charset="0"/>
                <a:cs typeface="Times New Roman" pitchFamily="18" charset="0"/>
              </a:rPr>
              <a:t>Multiple </a:t>
            </a:r>
            <a:r>
              <a:rPr lang="en-US" altLang="zh-CN" sz="1496" dirty="0">
                <a:latin typeface="Times New Roman" pitchFamily="18" charset="0"/>
                <a:cs typeface="Times New Roman" pitchFamily="18" charset="0"/>
              </a:rPr>
              <a:t>alignment of the DNA sequences of </a:t>
            </a:r>
            <a:r>
              <a:rPr lang="en-US" altLang="zh-CN" sz="1496" i="1" dirty="0">
                <a:latin typeface="Times New Roman" pitchFamily="18" charset="0"/>
                <a:cs typeface="Times New Roman" pitchFamily="18" charset="0"/>
              </a:rPr>
              <a:t>Xrj5</a:t>
            </a:r>
            <a:r>
              <a:rPr lang="en-US" altLang="zh-CN" sz="1496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496" dirty="0" err="1">
                <a:latin typeface="Times New Roman" pitchFamily="18" charset="0"/>
                <a:cs typeface="Times New Roman" pitchFamily="18" charset="0"/>
              </a:rPr>
              <a:t>amplicons</a:t>
            </a:r>
            <a:r>
              <a:rPr lang="en-US" altLang="zh-CN" sz="1496" dirty="0">
                <a:latin typeface="Times New Roman" pitchFamily="18" charset="0"/>
                <a:cs typeface="Times New Roman" pitchFamily="18" charset="0"/>
              </a:rPr>
              <a:t> from G1812, Langdon and Renan. The difference of </a:t>
            </a:r>
            <a:r>
              <a:rPr lang="en-US" altLang="zh-CN" sz="1496" dirty="0" err="1">
                <a:latin typeface="Times New Roman" pitchFamily="18" charset="0"/>
                <a:cs typeface="Times New Roman" pitchFamily="18" charset="0"/>
              </a:rPr>
              <a:t>amplicons</a:t>
            </a:r>
            <a:r>
              <a:rPr lang="en-US" altLang="zh-CN" sz="1496" dirty="0">
                <a:latin typeface="Times New Roman" pitchFamily="18" charset="0"/>
                <a:cs typeface="Times New Roman" pitchFamily="18" charset="0"/>
              </a:rPr>
              <a:t> among them was indicated by dashed lines</a:t>
            </a:r>
            <a:r>
              <a:rPr lang="en-US" altLang="zh-CN" sz="1496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ngth (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 of each sequence was indicated at the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′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d.</a:t>
            </a:r>
            <a:endParaRPr lang="zh-CN" altLang="zh-CN" sz="1496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3750" y="390953"/>
            <a:ext cx="10344018" cy="78232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99050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1</TotalTime>
  <Words>46</Words>
  <Application>Microsoft Office PowerPoint</Application>
  <PresentationFormat>自定义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zy</dc:creator>
  <cp:lastModifiedBy>dzy</cp:lastModifiedBy>
  <cp:revision>17</cp:revision>
  <dcterms:created xsi:type="dcterms:W3CDTF">2015-08-20T11:18:46Z</dcterms:created>
  <dcterms:modified xsi:type="dcterms:W3CDTF">2017-05-09T07:26:43Z</dcterms:modified>
</cp:coreProperties>
</file>